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228600" y="787320"/>
          <a:ext cx="4267080" cy="2846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" y="787320"/>
                    <a:ext cx="4267080" cy="2846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0" name=""/>
          <p:cNvGraphicFramePr/>
          <p:nvPr/>
        </p:nvGraphicFramePr>
        <p:xfrm>
          <a:off x="4648320" y="762120"/>
          <a:ext cx="4267080" cy="28461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648320" y="762120"/>
                    <a:ext cx="4267080" cy="2846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228600" y="3478320"/>
          <a:ext cx="4267080" cy="28461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28600" y="3478320"/>
                    <a:ext cx="4267080" cy="2846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2057400" y="1066680"/>
            <a:ext cx="2362320" cy="582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o Vaccin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1.5 cases/1000 (sd 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4648320" y="3478320"/>
          <a:ext cx="4267080" cy="28461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648320" y="3478320"/>
                    <a:ext cx="4267080" cy="2846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>
            <a:off x="6019920" y="990720"/>
            <a:ext cx="2971800" cy="852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% Vaccin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Un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3.5 cases/1000 (2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.1 cases/1000 (0.9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019920" y="3862440"/>
            <a:ext cx="2971800" cy="852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0% Vaccin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Un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4 cases/1000 (0.3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1 cases/1000 (0.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23880" y="3862440"/>
            <a:ext cx="2971800" cy="852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% Vaccin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Un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.3 cases/1000 (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cc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4 cases/1000 (0.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514600" y="604512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921360" y="604512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-663120" y="1698120"/>
            <a:ext cx="175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holera Cas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-656640" y="4365000"/>
            <a:ext cx="175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holera Cas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478800" y="36828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62120" y="99072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257800" y="9907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62120" y="373392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257800" y="37479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3:00:47Z</dcterms:modified>
  <cp:revision>298</cp:revision>
  <dc:subject/>
  <dc:title>Slide 1</dc:title>
</cp:coreProperties>
</file>